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709A01-0816-A25D-9DFB-8F8FCC87DE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419703-63E6-2568-10C4-5802D7DCA6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B2E98-FA48-9DCE-F42C-0D14ED3A5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ACD7DC-717A-E0DD-F7E4-B6AAFC611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2A7E8E-96E4-D165-042B-1E23D83AF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031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5654C-39E5-BF35-D6C7-D4F95BE6E0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31516E-3A75-9856-9A55-91E6795276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C4FBA0-15AD-2510-9580-C364AA01E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84AA4-ED85-0AAC-94E7-3BD5D9360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C0E40D-3C55-A4AD-6344-265CAF0F6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668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894F56-C139-F305-7AC4-328ED22538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98FA4A-0B6A-02E8-700E-46EF82276D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8745E-A870-A790-37E0-2E6B65FEF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28460-E270-D0C7-1CC7-C82DD730E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3433E9-22EA-F15E-671D-C6FA5AC86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472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C1701-D703-CC26-A594-668310DBD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8A0E50-7651-34CD-D187-14F1AE9D1C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5176D-0133-E9E8-D3B2-CEC70A2F6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ED2E46-4270-35BD-765E-6E4712BC8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0F341B-A116-EBDB-B10E-89607F581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853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C72F2-6896-5767-6B46-1C35AD29D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E82FE-47D8-2DD8-9860-37C927248A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6F908-1217-7551-7EAD-15ADAC2AD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35E543-6FFF-EFF7-FFD9-EE40B84BA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0CCA5-C443-AEBC-3D0A-6A27549B4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569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5C9A03-A637-5653-F3A4-1D8AE7590B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02F10-1A8F-3133-C010-0FDF3C5B68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890C4A-A202-D82F-53A0-58DB6645C7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4699C2-D5C6-E223-3BDF-54FB33DFA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A425B8-604F-7B0C-F2FB-AD8E182AB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77CAC4-36A6-1C0A-2DDB-499DEF1D9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5CE001-694E-0D31-E83A-80D7DECFC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567FF6-971D-5147-04B7-2DF094990F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FB9096-2849-E1F3-0E2D-A6747162F1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39B16D-6EFD-27BC-BF75-90A687D99A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CE937D-0AC0-D514-B8B9-8E72929799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8BC135-011A-FE4D-F691-5FA48F8D4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21B987-6C35-76BD-F42B-7D15EA076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B73C3A-DF4D-A09A-5C76-5F3013411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544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58DAB-E564-E569-4469-2628B9F46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B2B7A8-43D9-A7D1-BAA1-109F37327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858BA8-1F12-07C6-15B4-17F7D4991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4FE64E-6356-0458-D3B8-C54A96AA2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16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73C83BD-88CA-6BD3-3728-BA8F784D8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F67FA8-3561-8843-779C-57ED21484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648AFC-8051-D5DE-4E8B-ADA1A1464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041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2C104A-DE6D-DC16-CBC9-F850682E8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AA9A13-4366-2B4F-51F3-21737175D1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00CE40-775B-D4DB-C971-252F063A1A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0A5593-CDD8-DC58-BD72-C2671163E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224E26-E2C1-C502-DE4D-512B477B6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29BFB8-4D48-CC56-7AAE-118E03B51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33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9598D-0AE3-175E-D0FA-2BC537A39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C478F7-92C7-83F8-3273-BC291A2B2C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064F9A-8684-247D-5765-314928F9FE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5515E2-70EE-1EE1-8B25-28A0CA0D4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40FA26-3321-CD2A-B500-5ED300F42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069DE2-719F-229C-5ADD-79268660D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633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4F32CF-67BF-8042-95A9-48E66D97AE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DF4EC3-0FE1-77D0-1DD0-D25BB3D5FA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A3DB7D-EC51-44FA-3628-7117B640B2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2EBB5-38E2-42EC-99DE-0ACA70FCC9DE}" type="datetimeFigureOut">
              <a:rPr lang="en-US" smtClean="0"/>
              <a:t>11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D884CB-39A0-FD12-721C-4FD1FE28BD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AEEFA1-BBB2-EE4D-ACE3-E2A5A5348F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B2A87-9527-4A32-A6C9-B4D94A513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216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B4C4D9D-B772-A7AA-35E5-50D153F6BC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0263064"/>
              </p:ext>
            </p:extLst>
          </p:nvPr>
        </p:nvGraphicFramePr>
        <p:xfrm>
          <a:off x="546538" y="1049154"/>
          <a:ext cx="10992320" cy="4816837"/>
        </p:xfrm>
        <a:graphic>
          <a:graphicData uri="http://schemas.openxmlformats.org/drawingml/2006/table">
            <a:tbl>
              <a:tblPr/>
              <a:tblGrid>
                <a:gridCol w="1324303">
                  <a:extLst>
                    <a:ext uri="{9D8B030D-6E8A-4147-A177-3AD203B41FA5}">
                      <a16:colId xmlns:a16="http://schemas.microsoft.com/office/drawing/2014/main" val="3277144683"/>
                    </a:ext>
                  </a:extLst>
                </a:gridCol>
                <a:gridCol w="1039786">
                  <a:extLst>
                    <a:ext uri="{9D8B030D-6E8A-4147-A177-3AD203B41FA5}">
                      <a16:colId xmlns:a16="http://schemas.microsoft.com/office/drawing/2014/main" val="3512850964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3764450401"/>
                    </a:ext>
                  </a:extLst>
                </a:gridCol>
                <a:gridCol w="981730">
                  <a:extLst>
                    <a:ext uri="{9D8B030D-6E8A-4147-A177-3AD203B41FA5}">
                      <a16:colId xmlns:a16="http://schemas.microsoft.com/office/drawing/2014/main" val="1339043695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2294524225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3762532014"/>
                    </a:ext>
                  </a:extLst>
                </a:gridCol>
                <a:gridCol w="868453">
                  <a:extLst>
                    <a:ext uri="{9D8B030D-6E8A-4147-A177-3AD203B41FA5}">
                      <a16:colId xmlns:a16="http://schemas.microsoft.com/office/drawing/2014/main" val="3017236363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903905372"/>
                    </a:ext>
                  </a:extLst>
                </a:gridCol>
                <a:gridCol w="962846">
                  <a:extLst>
                    <a:ext uri="{9D8B030D-6E8A-4147-A177-3AD203B41FA5}">
                      <a16:colId xmlns:a16="http://schemas.microsoft.com/office/drawing/2014/main" val="310262416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2281915723"/>
                    </a:ext>
                  </a:extLst>
                </a:gridCol>
                <a:gridCol w="821252">
                  <a:extLst>
                    <a:ext uri="{9D8B030D-6E8A-4147-A177-3AD203B41FA5}">
                      <a16:colId xmlns:a16="http://schemas.microsoft.com/office/drawing/2014/main" val="3300005965"/>
                    </a:ext>
                  </a:extLst>
                </a:gridCol>
                <a:gridCol w="887690">
                  <a:extLst>
                    <a:ext uri="{9D8B030D-6E8A-4147-A177-3AD203B41FA5}">
                      <a16:colId xmlns:a16="http://schemas.microsoft.com/office/drawing/2014/main" val="938127904"/>
                    </a:ext>
                  </a:extLst>
                </a:gridCol>
              </a:tblGrid>
              <a:tr h="89456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richome type​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Line art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INK TIGER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UNGOLD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INDIGO CHERRY DROPS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IDY TREATS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URPLE </a:t>
                      </a:r>
                    </a:p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BUMBLE BEE​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BLACK KRIM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INK BERKELEY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BIG BEEF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BLACK </a:t>
                      </a:r>
                    </a:p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RINCE​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UPERSWEET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1800942"/>
                  </a:ext>
                </a:extLst>
              </a:tr>
              <a:tr h="1304570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. Hooked subulate glandular hair with multicellular jointed stalk and small glandular tip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67391"/>
                  </a:ext>
                </a:extLst>
              </a:tr>
              <a:tr h="75789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2. Glandular hair with large globular head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9037321"/>
                  </a:ext>
                </a:extLst>
              </a:tr>
              <a:tr h="828579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. Glandular hair with quadricellular head​</a:t>
                      </a:r>
                      <a:endParaRPr lang="en-US" sz="20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5092359"/>
                  </a:ext>
                </a:extLst>
              </a:tr>
              <a:tr h="1031232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4. Attenuate glandular hair with small glandular tip​</a:t>
                      </a:r>
                      <a:endParaRPr lang="en-US" sz="20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20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10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935" marR="58935" marT="29467" marB="29467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287087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7715FBC-F2D8-9F19-2CDD-31BDE897D775}"/>
              </a:ext>
            </a:extLst>
          </p:cNvPr>
          <p:cNvSpPr txBox="1"/>
          <p:nvPr/>
        </p:nvSpPr>
        <p:spPr>
          <a:xfrm>
            <a:off x="1138989" y="452751"/>
            <a:ext cx="10347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Calibri Light" panose="020F0302020204030204" pitchFamily="34" charset="0"/>
              </a:rPr>
              <a:t>Table 1. Different types of trichomes present in ten varieties of tomato and their line-art representation</a:t>
            </a:r>
            <a:endParaRPr lang="en-US" dirty="0"/>
          </a:p>
        </p:txBody>
      </p:sp>
      <p:pic>
        <p:nvPicPr>
          <p:cNvPr id="6" name="Picture 5" descr="A black rectangle with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F13E7CC2-B125-FA6A-295F-FBBA8FF649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5996795">
            <a:off x="1880760" y="2171648"/>
            <a:ext cx="841419" cy="863799"/>
          </a:xfrm>
          <a:prstGeom prst="rect">
            <a:avLst/>
          </a:prstGeom>
        </p:spPr>
      </p:pic>
      <p:pic>
        <p:nvPicPr>
          <p:cNvPr id="8" name="Picture 7" descr="Shape&#10;&#10;Description automatically generated with medium confidence">
            <a:extLst>
              <a:ext uri="{FF2B5EF4-FFF2-40B4-BE49-F238E27FC236}">
                <a16:creationId xmlns:a16="http://schemas.microsoft.com/office/drawing/2014/main" id="{DD922041-D187-2AD6-15ED-6ED55F2F3E2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524607">
            <a:off x="1918318" y="3244354"/>
            <a:ext cx="766301" cy="625710"/>
          </a:xfrm>
          <a:prstGeom prst="rect">
            <a:avLst/>
          </a:prstGeom>
        </p:spPr>
      </p:pic>
      <p:pic>
        <p:nvPicPr>
          <p:cNvPr id="10" name="Picture 9" descr="Shape&#10;&#10;Description automatically generated with low confidence">
            <a:extLst>
              <a:ext uri="{FF2B5EF4-FFF2-40B4-BE49-F238E27FC236}">
                <a16:creationId xmlns:a16="http://schemas.microsoft.com/office/drawing/2014/main" id="{39FD074D-6A57-BABB-99B8-872C3F13BB1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4511" y="4056318"/>
            <a:ext cx="914082" cy="788802"/>
          </a:xfrm>
          <a:prstGeom prst="rect">
            <a:avLst/>
          </a:prstGeom>
        </p:spPr>
      </p:pic>
      <p:pic>
        <p:nvPicPr>
          <p:cNvPr id="12" name="Picture 11" descr="Shape&#10;&#10;Description automatically generated with low confidence">
            <a:extLst>
              <a:ext uri="{FF2B5EF4-FFF2-40B4-BE49-F238E27FC236}">
                <a16:creationId xmlns:a16="http://schemas.microsoft.com/office/drawing/2014/main" id="{DE8425E3-F746-031B-1346-BCAB8EAA8E5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3312" y="4828833"/>
            <a:ext cx="496311" cy="1053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02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F5E1B30-76F8-EFF2-8F62-B112876BCAAE}"/>
              </a:ext>
            </a:extLst>
          </p:cNvPr>
          <p:cNvGraphicFramePr>
            <a:graphicFrameLocks noGrp="1"/>
          </p:cNvGraphicFramePr>
          <p:nvPr/>
        </p:nvGraphicFramePr>
        <p:xfrm>
          <a:off x="2877249" y="1813544"/>
          <a:ext cx="6437501" cy="4375500"/>
        </p:xfrm>
        <a:graphic>
          <a:graphicData uri="http://schemas.openxmlformats.org/drawingml/2006/table">
            <a:tbl>
              <a:tblPr/>
              <a:tblGrid>
                <a:gridCol w="1181930">
                  <a:extLst>
                    <a:ext uri="{9D8B030D-6E8A-4147-A177-3AD203B41FA5}">
                      <a16:colId xmlns:a16="http://schemas.microsoft.com/office/drawing/2014/main" val="2144436363"/>
                    </a:ext>
                  </a:extLst>
                </a:gridCol>
                <a:gridCol w="235238">
                  <a:extLst>
                    <a:ext uri="{9D8B030D-6E8A-4147-A177-3AD203B41FA5}">
                      <a16:colId xmlns:a16="http://schemas.microsoft.com/office/drawing/2014/main" val="3713923452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2232312290"/>
                    </a:ext>
                  </a:extLst>
                </a:gridCol>
                <a:gridCol w="573752">
                  <a:extLst>
                    <a:ext uri="{9D8B030D-6E8A-4147-A177-3AD203B41FA5}">
                      <a16:colId xmlns:a16="http://schemas.microsoft.com/office/drawing/2014/main" val="1310228757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973630569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3482681361"/>
                    </a:ext>
                  </a:extLst>
                </a:gridCol>
                <a:gridCol w="510640">
                  <a:extLst>
                    <a:ext uri="{9D8B030D-6E8A-4147-A177-3AD203B41FA5}">
                      <a16:colId xmlns:a16="http://schemas.microsoft.com/office/drawing/2014/main" val="3923297378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334370077"/>
                    </a:ext>
                  </a:extLst>
                </a:gridCol>
                <a:gridCol w="562277">
                  <a:extLst>
                    <a:ext uri="{9D8B030D-6E8A-4147-A177-3AD203B41FA5}">
                      <a16:colId xmlns:a16="http://schemas.microsoft.com/office/drawing/2014/main" val="1332662234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2670548873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564538260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3506643871"/>
                    </a:ext>
                  </a:extLst>
                </a:gridCol>
              </a:tblGrid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 Acuminate glandular hair with bicellular stalk and small glandular tip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1" i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1" i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3489694"/>
                  </a:ext>
                </a:extLst>
              </a:tr>
              <a:tr h="1142915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 Subulate glandular hair with multicellular jointed stalk, multicellular base, small glandular tip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9538899"/>
                  </a:ext>
                </a:extLst>
              </a:tr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 Subulate non-glandular hair with pulvinate base and pedestal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2599660"/>
                  </a:ext>
                </a:extLst>
              </a:tr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 Crescent non-glandular with multicellular jointed stalk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0383467"/>
                  </a:ext>
                </a:extLst>
              </a:tr>
              <a:tr h="1142915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0. Subulate non-glandular hair with multicellular jointed stalk, multicellular base and distinct subsidiary cells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224184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2C818A27-8E94-D169-2BEA-97069D24A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6550" y="18129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D9D6303-C6F3-13CD-3C53-45AD33B8195C}"/>
              </a:ext>
            </a:extLst>
          </p:cNvPr>
          <p:cNvGraphicFramePr>
            <a:graphicFrameLocks noGrp="1"/>
          </p:cNvGraphicFramePr>
          <p:nvPr/>
        </p:nvGraphicFramePr>
        <p:xfrm>
          <a:off x="2877249" y="1813544"/>
          <a:ext cx="6437501" cy="4375500"/>
        </p:xfrm>
        <a:graphic>
          <a:graphicData uri="http://schemas.openxmlformats.org/drawingml/2006/table">
            <a:tbl>
              <a:tblPr/>
              <a:tblGrid>
                <a:gridCol w="1181930">
                  <a:extLst>
                    <a:ext uri="{9D8B030D-6E8A-4147-A177-3AD203B41FA5}">
                      <a16:colId xmlns:a16="http://schemas.microsoft.com/office/drawing/2014/main" val="3601891344"/>
                    </a:ext>
                  </a:extLst>
                </a:gridCol>
                <a:gridCol w="235238">
                  <a:extLst>
                    <a:ext uri="{9D8B030D-6E8A-4147-A177-3AD203B41FA5}">
                      <a16:colId xmlns:a16="http://schemas.microsoft.com/office/drawing/2014/main" val="836971469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1561340031"/>
                    </a:ext>
                  </a:extLst>
                </a:gridCol>
                <a:gridCol w="573752">
                  <a:extLst>
                    <a:ext uri="{9D8B030D-6E8A-4147-A177-3AD203B41FA5}">
                      <a16:colId xmlns:a16="http://schemas.microsoft.com/office/drawing/2014/main" val="3849201369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702394113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1901432814"/>
                    </a:ext>
                  </a:extLst>
                </a:gridCol>
                <a:gridCol w="510640">
                  <a:extLst>
                    <a:ext uri="{9D8B030D-6E8A-4147-A177-3AD203B41FA5}">
                      <a16:colId xmlns:a16="http://schemas.microsoft.com/office/drawing/2014/main" val="2140127268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3470077041"/>
                    </a:ext>
                  </a:extLst>
                </a:gridCol>
                <a:gridCol w="562277">
                  <a:extLst>
                    <a:ext uri="{9D8B030D-6E8A-4147-A177-3AD203B41FA5}">
                      <a16:colId xmlns:a16="http://schemas.microsoft.com/office/drawing/2014/main" val="797132742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3149375759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1709630653"/>
                    </a:ext>
                  </a:extLst>
                </a:gridCol>
                <a:gridCol w="481952">
                  <a:extLst>
                    <a:ext uri="{9D8B030D-6E8A-4147-A177-3AD203B41FA5}">
                      <a16:colId xmlns:a16="http://schemas.microsoft.com/office/drawing/2014/main" val="1846494352"/>
                    </a:ext>
                  </a:extLst>
                </a:gridCol>
              </a:tblGrid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 Acuminate glandular hair with bicellular stalk and small glandular tip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1" i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1" i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7059672"/>
                  </a:ext>
                </a:extLst>
              </a:tr>
              <a:tr h="1142915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 Subulate glandular hair with multicellular jointed stalk, multicellular base, small glandular tip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84919"/>
                  </a:ext>
                </a:extLst>
              </a:tr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 Subulate non-glandular hair with pulvinate base and pedestal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8676554"/>
                  </a:ext>
                </a:extLst>
              </a:tr>
              <a:tr h="6885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 Crescent non-glandular with multicellular jointed stalk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8172972"/>
                  </a:ext>
                </a:extLst>
              </a:tr>
              <a:tr h="1142915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10. Subulate non-glandular hair with multicellular jointed stalk, multicellular base and distinct subsidiary cells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Char char="•"/>
                      </a:pP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4659141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8E727F8F-6A08-4BEA-97DE-27B6791B6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6550" y="18129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59C58EEA-53F7-76F1-C79D-84B721B6E0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7519892"/>
              </p:ext>
            </p:extLst>
          </p:nvPr>
        </p:nvGraphicFramePr>
        <p:xfrm>
          <a:off x="640080" y="548641"/>
          <a:ext cx="10197964" cy="5640402"/>
        </p:xfrm>
        <a:graphic>
          <a:graphicData uri="http://schemas.openxmlformats.org/drawingml/2006/table">
            <a:tbl>
              <a:tblPr/>
              <a:tblGrid>
                <a:gridCol w="1645920">
                  <a:extLst>
                    <a:ext uri="{9D8B030D-6E8A-4147-A177-3AD203B41FA5}">
                      <a16:colId xmlns:a16="http://schemas.microsoft.com/office/drawing/2014/main" val="641741107"/>
                    </a:ext>
                  </a:extLst>
                </a:gridCol>
                <a:gridCol w="1263397">
                  <a:extLst>
                    <a:ext uri="{9D8B030D-6E8A-4147-A177-3AD203B41FA5}">
                      <a16:colId xmlns:a16="http://schemas.microsoft.com/office/drawing/2014/main" val="795558326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783223120"/>
                    </a:ext>
                  </a:extLst>
                </a:gridCol>
                <a:gridCol w="832988">
                  <a:extLst>
                    <a:ext uri="{9D8B030D-6E8A-4147-A177-3AD203B41FA5}">
                      <a16:colId xmlns:a16="http://schemas.microsoft.com/office/drawing/2014/main" val="1179231009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4146794587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4161170706"/>
                    </a:ext>
                  </a:extLst>
                </a:gridCol>
                <a:gridCol w="741360">
                  <a:extLst>
                    <a:ext uri="{9D8B030D-6E8A-4147-A177-3AD203B41FA5}">
                      <a16:colId xmlns:a16="http://schemas.microsoft.com/office/drawing/2014/main" val="716827745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2190579621"/>
                    </a:ext>
                  </a:extLst>
                </a:gridCol>
                <a:gridCol w="816329">
                  <a:extLst>
                    <a:ext uri="{9D8B030D-6E8A-4147-A177-3AD203B41FA5}">
                      <a16:colId xmlns:a16="http://schemas.microsoft.com/office/drawing/2014/main" val="2908226537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968071957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944190893"/>
                    </a:ext>
                  </a:extLst>
                </a:gridCol>
                <a:gridCol w="699710">
                  <a:extLst>
                    <a:ext uri="{9D8B030D-6E8A-4147-A177-3AD203B41FA5}">
                      <a16:colId xmlns:a16="http://schemas.microsoft.com/office/drawing/2014/main" val="2493794706"/>
                    </a:ext>
                  </a:extLst>
                </a:gridCol>
              </a:tblGrid>
              <a:tr h="892332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5. Acuminate glandular hair with bicellular stalk and small glandular tip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1" i="0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1" i="0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1" i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3344996"/>
                  </a:ext>
                </a:extLst>
              </a:tr>
              <a:tr h="14817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6. Subulate glandular hair with multicellular jointed stalk, multicellular base, small glandular tip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397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2417297"/>
                  </a:ext>
                </a:extLst>
              </a:tr>
              <a:tr h="892332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7. Subulate non-glandular hair with pulvinate base and pedestal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1459494"/>
                  </a:ext>
                </a:extLst>
              </a:tr>
              <a:tr h="892332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8. Crescent non-glandular with multicellular jointed stalk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7813590"/>
                  </a:ext>
                </a:extLst>
              </a:tr>
              <a:tr h="1481703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1" i="0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9. Subulate non-glandular hair with multicellular jointed stalk, multicellular base and distinct subsidiary cells​</a:t>
                      </a:r>
                      <a:endParaRPr lang="en-US" sz="1600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​</a:t>
                      </a:r>
                      <a:endParaRPr lang="en-US" sz="16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1000" dirty="0">
                          <a:sym typeface="Wingdings" panose="05000000000000000000" pitchFamily="2" charset="2"/>
                        </a:rPr>
                        <a:t></a:t>
                      </a: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buFont typeface="Arial" panose="020B0604020202020204" pitchFamily="34" charset="0"/>
                        <a:buNone/>
                      </a:pPr>
                      <a:r>
                        <a:rPr lang="en-US" sz="800" dirty="0">
                          <a:sym typeface="Wingdings" panose="05000000000000000000" pitchFamily="2" charset="2"/>
                        </a:rPr>
                        <a:t></a:t>
                      </a:r>
                      <a:endParaRPr lang="en-US" sz="8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2620" marR="82620" marT="41310" marB="41310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8365134"/>
                  </a:ext>
                </a:extLst>
              </a:tr>
            </a:tbl>
          </a:graphicData>
        </a:graphic>
      </p:graphicFrame>
      <p:sp>
        <p:nvSpPr>
          <p:cNvPr id="7" name="Rectangle 3">
            <a:extLst>
              <a:ext uri="{FF2B5EF4-FFF2-40B4-BE49-F238E27FC236}">
                <a16:creationId xmlns:a16="http://schemas.microsoft.com/office/drawing/2014/main" id="{87BC507A-959F-F313-B79B-1DDE52D0FC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6550" y="18129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9" name="Picture 8" descr="Shape&#10;&#10;Description automatically generated with low confidence">
            <a:extLst>
              <a:ext uri="{FF2B5EF4-FFF2-40B4-BE49-F238E27FC236}">
                <a16:creationId xmlns:a16="http://schemas.microsoft.com/office/drawing/2014/main" id="{C13F9494-B9DD-891F-F364-025D399EF4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738194">
            <a:off x="2819399" y="394672"/>
            <a:ext cx="311137" cy="1184150"/>
          </a:xfrm>
          <a:prstGeom prst="rect">
            <a:avLst/>
          </a:prstGeom>
        </p:spPr>
      </p:pic>
      <p:pic>
        <p:nvPicPr>
          <p:cNvPr id="11" name="Picture 10" descr="Shape&#10;&#10;Description automatically generated with medium confidence">
            <a:extLst>
              <a:ext uri="{FF2B5EF4-FFF2-40B4-BE49-F238E27FC236}">
                <a16:creationId xmlns:a16="http://schemas.microsoft.com/office/drawing/2014/main" id="{AC33D868-C771-FF5F-0B71-82714A3709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0008" y="1614716"/>
            <a:ext cx="1193084" cy="1253122"/>
          </a:xfrm>
          <a:prstGeom prst="rect">
            <a:avLst/>
          </a:prstGeom>
        </p:spPr>
      </p:pic>
      <p:pic>
        <p:nvPicPr>
          <p:cNvPr id="13" name="Picture 12" descr="Shape&#10;&#10;Description automatically generated with low confidence">
            <a:extLst>
              <a:ext uri="{FF2B5EF4-FFF2-40B4-BE49-F238E27FC236}">
                <a16:creationId xmlns:a16="http://schemas.microsoft.com/office/drawing/2014/main" id="{41B490AE-4E8F-0A2B-3916-B215CB9875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9840" y="2902178"/>
            <a:ext cx="949803" cy="865749"/>
          </a:xfrm>
          <a:prstGeom prst="rect">
            <a:avLst/>
          </a:prstGeom>
        </p:spPr>
      </p:pic>
      <p:pic>
        <p:nvPicPr>
          <p:cNvPr id="15" name="Picture 14" descr="Shape&#10;&#10;Description automatically generated with low confidence">
            <a:extLst>
              <a:ext uri="{FF2B5EF4-FFF2-40B4-BE49-F238E27FC236}">
                <a16:creationId xmlns:a16="http://schemas.microsoft.com/office/drawing/2014/main" id="{05FDA08E-B645-828F-B504-9CC1EFF3963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368642">
            <a:off x="2378425" y="3802268"/>
            <a:ext cx="811815" cy="1041936"/>
          </a:xfrm>
          <a:prstGeom prst="rect">
            <a:avLst/>
          </a:prstGeom>
        </p:spPr>
      </p:pic>
      <p:pic>
        <p:nvPicPr>
          <p:cNvPr id="17" name="Picture 16" descr="Shape&#10;&#10;Description automatically generated with low confidence">
            <a:extLst>
              <a:ext uri="{FF2B5EF4-FFF2-40B4-BE49-F238E27FC236}">
                <a16:creationId xmlns:a16="http://schemas.microsoft.com/office/drawing/2014/main" id="{718499F3-B5AB-1C74-C21E-EEF205C768D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0027" y="4747151"/>
            <a:ext cx="733046" cy="1373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4106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489</Words>
  <Application>Microsoft Macintosh PowerPoint</Application>
  <PresentationFormat>Widescreen</PresentationFormat>
  <Paragraphs>24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inderpal Kaur</dc:creator>
  <cp:lastModifiedBy>Rupesh Kariyat</cp:lastModifiedBy>
  <cp:revision>4</cp:revision>
  <dcterms:created xsi:type="dcterms:W3CDTF">2022-10-04T05:08:27Z</dcterms:created>
  <dcterms:modified xsi:type="dcterms:W3CDTF">2022-11-01T20:14:30Z</dcterms:modified>
</cp:coreProperties>
</file>